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63634F-2745-4077-8071-5BF4BB7C405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3B22C8-888C-48A6-89DC-6A68E5CA9D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0ED0CE-7D1E-43C0-B8D5-E5B8F8853F3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6D765D-CA8E-49D4-B533-3DB7F025AFE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F4D9F6-275F-4207-8559-5F8E8C900D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6816E-9D59-4609-96AC-A3E1A6B788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89D77C-9569-4522-A04B-A4638D6794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E9110A-044C-418B-A7C9-300435EC9D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71E7B9-5514-48E1-9548-13A210385E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355DAF-C0BD-426B-9FBB-A1E02E1DCF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C45FE2-A64D-4038-914C-D1AC7FF2C2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276840-83D4-41F5-8E96-9513492E2F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A37FD9-FC66-492C-B3AD-218EC8C256E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84640" y="1371600"/>
            <a:ext cx="8118000" cy="3032640"/>
            <a:chOff x="584640" y="1371600"/>
            <a:chExt cx="8118000" cy="3032640"/>
          </a:xfrm>
        </p:grpSpPr>
        <p:sp>
          <p:nvSpPr>
            <p:cNvPr id="42" name=""/>
            <p:cNvSpPr/>
            <p:nvPr/>
          </p:nvSpPr>
          <p:spPr>
            <a:xfrm>
              <a:off x="1620720" y="2100240"/>
              <a:ext cx="3102120" cy="1503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814400" y="2585880"/>
              <a:ext cx="395280" cy="1017720"/>
            </a:xfrm>
            <a:prstGeom prst="rect">
              <a:avLst/>
            </a:prstGeom>
            <a:solidFill>
              <a:srgbClr val="ffffff"/>
            </a:solidFill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595600" y="2347920"/>
              <a:ext cx="384120" cy="1255680"/>
            </a:xfrm>
            <a:prstGeom prst="rect">
              <a:avLst/>
            </a:prstGeom>
            <a:solidFill>
              <a:srgbClr val="ffffff"/>
            </a:solidFill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363840" y="3116160"/>
              <a:ext cx="397080" cy="487440"/>
            </a:xfrm>
            <a:prstGeom prst="rect">
              <a:avLst/>
            </a:prstGeom>
            <a:solidFill>
              <a:srgbClr val="ffffff"/>
            </a:solidFill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145040" y="2743200"/>
              <a:ext cx="385560" cy="860400"/>
            </a:xfrm>
            <a:prstGeom prst="rect">
              <a:avLst/>
            </a:prstGeom>
            <a:solidFill>
              <a:srgbClr val="ffffff"/>
            </a:solidFill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flipV="1">
              <a:off x="2006640" y="2517480"/>
              <a:ext cx="0" cy="680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971720" y="2517840"/>
              <a:ext cx="79200" cy="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flipV="1">
              <a:off x="2787480" y="2292480"/>
              <a:ext cx="0" cy="55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752560" y="2292480"/>
              <a:ext cx="79560" cy="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flipV="1">
              <a:off x="3557520" y="3049200"/>
              <a:ext cx="0" cy="6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522600" y="3049560"/>
              <a:ext cx="79560" cy="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flipV="1">
              <a:off x="4338720" y="2698560"/>
              <a:ext cx="0" cy="442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303800" y="2698920"/>
              <a:ext cx="79200" cy="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620720" y="2100240"/>
              <a:ext cx="46080" cy="1503360"/>
            </a:xfrm>
            <a:custGeom>
              <a:avLst/>
              <a:gdLst/>
              <a:ahLst/>
              <a:rect l="l" t="t" r="r" b="b"/>
              <a:pathLst>
                <a:path w="4" h="133">
                  <a:moveTo>
                    <a:pt x="0" y="0"/>
                  </a:moveTo>
                  <a:lnTo>
                    <a:pt x="0" y="133"/>
                  </a:lnTo>
                  <a:lnTo>
                    <a:pt x="4" y="133"/>
                  </a:lnTo>
                </a:path>
              </a:pathLst>
            </a:custGeom>
            <a:noFill/>
            <a:ln w="223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620720" y="3354480"/>
              <a:ext cx="4608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620720" y="3105000"/>
              <a:ext cx="4608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620720" y="2857680"/>
              <a:ext cx="4608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620720" y="2597040"/>
              <a:ext cx="4608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620720" y="2347920"/>
              <a:ext cx="4608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620720" y="2100240"/>
              <a:ext cx="4608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620720" y="3603600"/>
              <a:ext cx="310212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427760" y="35132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314720" y="32637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314720" y="30146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314720" y="27669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314720" y="25066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427760" y="225756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314720" y="20098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rot="19800000">
              <a:off x="1048320" y="3917520"/>
              <a:ext cx="1079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vehicle 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rot="19800000">
              <a:off x="1743480" y="3938400"/>
              <a:ext cx="1180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negative 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rot="19800000">
              <a:off x="3055320" y="3812760"/>
              <a:ext cx="550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iDHF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rot="19800000">
              <a:off x="3761640" y="3836520"/>
              <a:ext cx="5950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iR-2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rot="16200000">
              <a:off x="244440" y="2627280"/>
              <a:ext cx="1828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elative mRNA level of DHF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521160" y="2687760"/>
              <a:ext cx="8928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5624640" y="2027160"/>
              <a:ext cx="3078000" cy="15591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5818320" y="2333520"/>
              <a:ext cx="382320" cy="1252800"/>
            </a:xfrm>
            <a:prstGeom prst="rect">
              <a:avLst/>
            </a:prstGeom>
            <a:solidFill>
              <a:srgbClr val="ffffff"/>
            </a:solidFill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6583320" y="2292480"/>
              <a:ext cx="395280" cy="1293840"/>
            </a:xfrm>
            <a:prstGeom prst="rect">
              <a:avLst/>
            </a:prstGeom>
            <a:solidFill>
              <a:srgbClr val="ffffff"/>
            </a:solidFill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7361280" y="3360600"/>
              <a:ext cx="384120" cy="225720"/>
            </a:xfrm>
            <a:prstGeom prst="rect">
              <a:avLst/>
            </a:prstGeom>
            <a:solidFill>
              <a:srgbClr val="ffffff"/>
            </a:solidFill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8128080" y="2598840"/>
              <a:ext cx="384120" cy="987480"/>
            </a:xfrm>
            <a:prstGeom prst="rect">
              <a:avLst/>
            </a:prstGeom>
            <a:solidFill>
              <a:srgbClr val="ffffff"/>
            </a:solidFill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V="1">
              <a:off x="6008760" y="2266560"/>
              <a:ext cx="0" cy="6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5975280" y="2266920"/>
              <a:ext cx="79560" cy="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V="1">
              <a:off x="6775560" y="2226960"/>
              <a:ext cx="0" cy="651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6742080" y="2227320"/>
              <a:ext cx="77760" cy="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V="1">
              <a:off x="7553160" y="3267000"/>
              <a:ext cx="0" cy="93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7518240" y="3267000"/>
              <a:ext cx="79560" cy="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flipV="1">
              <a:off x="8319960" y="2533320"/>
              <a:ext cx="0" cy="651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8285040" y="2533680"/>
              <a:ext cx="79560" cy="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5624640" y="2027160"/>
              <a:ext cx="46080" cy="1559160"/>
            </a:xfrm>
            <a:custGeom>
              <a:avLst/>
              <a:gdLst/>
              <a:ahLst/>
              <a:rect l="l" t="t" r="r" b="b"/>
              <a:pathLst>
                <a:path w="4" h="117">
                  <a:moveTo>
                    <a:pt x="0" y="0"/>
                  </a:moveTo>
                  <a:lnTo>
                    <a:pt x="0" y="117"/>
                  </a:lnTo>
                  <a:lnTo>
                    <a:pt x="4" y="117"/>
                  </a:lnTo>
                </a:path>
              </a:pathLst>
            </a:custGeom>
            <a:noFill/>
            <a:ln w="223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5624640" y="3321000"/>
              <a:ext cx="4608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5624640" y="3067200"/>
              <a:ext cx="4608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5624640" y="2798640"/>
              <a:ext cx="4608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5624640" y="2546280"/>
              <a:ext cx="4608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5624640" y="2279520"/>
              <a:ext cx="4608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5624640" y="2027160"/>
              <a:ext cx="4608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5624640" y="3586320"/>
              <a:ext cx="307800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5432400" y="347976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5319720" y="32130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5319720" y="29592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5319720" y="26924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5319720" y="24382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5432400" y="217332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5319720" y="19191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rot="19800000">
              <a:off x="5016960" y="3911400"/>
              <a:ext cx="1079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vehicle 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rot="19800000">
              <a:off x="5663160" y="3936600"/>
              <a:ext cx="1180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negative 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rot="19800000">
              <a:off x="7211520" y="3726000"/>
              <a:ext cx="323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i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rot="19800000">
              <a:off x="7740000" y="3811320"/>
              <a:ext cx="5950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iR-2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rot="16200000">
              <a:off x="4302000" y="2683800"/>
              <a:ext cx="167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elative mRNA level of T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7510680" y="2882880"/>
              <a:ext cx="7992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584640" y="1371600"/>
              <a:ext cx="44265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A                                             B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1" name=""/>
          <p:cNvSpPr/>
          <p:nvPr/>
        </p:nvSpPr>
        <p:spPr>
          <a:xfrm>
            <a:off x="3491640" y="4532400"/>
            <a:ext cx="203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HCT 116 (wt-p5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20T14:46:09Z</dcterms:created>
  <dc:creator>sbo</dc:creator>
  <dc:description/>
  <dc:language>en-US</dc:language>
  <cp:lastModifiedBy>sbo</cp:lastModifiedBy>
  <dcterms:modified xsi:type="dcterms:W3CDTF">2010-04-12T18:33:44Z</dcterms:modified>
  <cp:revision>6</cp:revision>
  <dc:subject/>
  <dc:title>Slide 1</dc:title>
</cp:coreProperties>
</file>